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A621C5-5840-4C1A-A8DC-1BB675C44D9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525B9D-BFF4-40AC-B84F-2EE0CFC6BE5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B34ADA-6255-4194-9DD5-B397D3DB3B9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9D86BF-F456-4A84-821B-F4EDA66F263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546856-C059-409A-A802-8FB02515508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7025E6-0DE4-4910-975F-F093ED15AFB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047B9C-91FA-4E55-AB29-7ADDDABE869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8E682A-7D02-4815-93AD-80010ADE83A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EBEB51-5E47-435F-9DEC-79D85CA08BB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5DCC65-542C-4E5F-B540-027B9311DB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1EE5D5-E372-4227-B843-1E570B316C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E764BE-12F2-4B04-A8B0-D04437F02C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0E83A6A-5D30-4ED2-A069-FC1273B06B8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4280" y="395280"/>
            <a:ext cx="6769440" cy="936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igure S2.  LD plots for </a:t>
            </a: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IL12B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variants genotyped in European (CEPH) and African (Yoruba) HapMap samples</a:t>
            </a: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*</a:t>
            </a:r>
            <a:r>
              <a:rPr b="0" lang="it-IT" sz="4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549360" y="1835280"/>
            <a:ext cx="2766960" cy="281124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2"/>
          <a:stretch/>
        </p:blipFill>
        <p:spPr>
          <a:xfrm>
            <a:off x="3716280" y="1835280"/>
            <a:ext cx="2743200" cy="2787480"/>
          </a:xfrm>
          <a:prstGeom prst="rect">
            <a:avLst/>
          </a:prstGeom>
          <a:ln w="0">
            <a:noFill/>
          </a:ln>
        </p:spPr>
      </p:pic>
      <p:pic>
        <p:nvPicPr>
          <p:cNvPr id="44" name="" descr=""/>
          <p:cNvPicPr/>
          <p:nvPr/>
        </p:nvPicPr>
        <p:blipFill>
          <a:blip r:embed="rId3"/>
          <a:stretch/>
        </p:blipFill>
        <p:spPr>
          <a:xfrm>
            <a:off x="541440" y="5292720"/>
            <a:ext cx="2743200" cy="2787480"/>
          </a:xfrm>
          <a:prstGeom prst="rect">
            <a:avLst/>
          </a:prstGeom>
          <a:ln w="0">
            <a:noFill/>
          </a:ln>
        </p:spPr>
      </p:pic>
      <p:pic>
        <p:nvPicPr>
          <p:cNvPr id="45" name="" descr=""/>
          <p:cNvPicPr/>
          <p:nvPr/>
        </p:nvPicPr>
        <p:blipFill>
          <a:blip r:embed="rId4"/>
          <a:stretch/>
        </p:blipFill>
        <p:spPr>
          <a:xfrm>
            <a:off x="3716280" y="5292720"/>
            <a:ext cx="2743200" cy="2787480"/>
          </a:xfrm>
          <a:prstGeom prst="rect">
            <a:avLst/>
          </a:prstGeom>
          <a:ln w="0">
            <a:noFill/>
          </a:ln>
        </p:spPr>
      </p:pic>
      <p:sp>
        <p:nvSpPr>
          <p:cNvPr id="46" name=""/>
          <p:cNvSpPr/>
          <p:nvPr/>
        </p:nvSpPr>
        <p:spPr>
          <a:xfrm>
            <a:off x="510840" y="1467720"/>
            <a:ext cx="298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.  </a:t>
            </a:r>
            <a:r>
              <a:rPr b="0" lang="en-GB" sz="1600" spc="-1" strike="noStrike">
                <a:solidFill>
                  <a:srgbClr val="000000"/>
                </a:solidFill>
                <a:latin typeface="Arial"/>
              </a:rPr>
              <a:t>CEPH HapMap D’</a:t>
            </a: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it-IT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3660840" y="1498320"/>
            <a:ext cx="2244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</a:rPr>
              <a:t>b.  Yoruba HapMap D’</a:t>
            </a:r>
            <a:r>
              <a:rPr b="0" lang="it-IT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510840" y="4925160"/>
            <a:ext cx="298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.  C</a:t>
            </a:r>
            <a:r>
              <a:rPr b="0" lang="en-GB" sz="1600" spc="-1" strike="noStrike">
                <a:solidFill>
                  <a:srgbClr val="000000"/>
                </a:solidFill>
                <a:latin typeface="Arial"/>
              </a:rPr>
              <a:t>EPH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HapMap r</a:t>
            </a:r>
            <a:r>
              <a:rPr b="0" lang="en-US" sz="16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it-IT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658680" y="4940280"/>
            <a:ext cx="2165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.  </a:t>
            </a:r>
            <a:r>
              <a:rPr b="0" lang="en-GB" sz="1600" spc="-1" strike="noStrike">
                <a:solidFill>
                  <a:srgbClr val="000000"/>
                </a:solidFill>
                <a:latin typeface="Arial"/>
              </a:rPr>
              <a:t>Yoruba HapMap r</a:t>
            </a:r>
            <a:r>
              <a:rPr b="0" lang="en-GB" sz="16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it-IT" sz="1800" spc="-1" strike="noStrike" baseline="30000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433440" y="8387640"/>
            <a:ext cx="5158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*Markers rs17860508 and rs10631390 genotype data is not available from the Hapmap.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4-23T13:55:42Z</dcterms:created>
  <dc:creator>fbf</dc:creator>
  <dc:description/>
  <dc:language>en-US</dc:language>
  <cp:lastModifiedBy>fbf</cp:lastModifiedBy>
  <dcterms:modified xsi:type="dcterms:W3CDTF">2010-12-22T17:37:53Z</dcterms:modified>
  <cp:revision>21</cp:revision>
  <dc:subject/>
  <dc:title>Supplemental Figure 1  Haploview plot for CEPH and Yoruba populations for IL12B</dc:title>
</cp:coreProperties>
</file>